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817D12-9C11-41BA-A058-CCD25C7631B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F52066-57C8-4FBB-9474-2BF43565C2B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3C7D39-F9A4-4640-B5C9-7E621F96414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7B2B5B-B8E4-4A7A-863B-2FEC4434576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9983B8-5617-4A52-8714-D7D649FA21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39EFAB-A638-4A30-89A4-B868E52ABA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BA0CE6-CBF4-47F2-A4F2-A7BB903C86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79E62E-7E2E-4C0D-B125-EB8AFC2B915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581AA5-D30B-4261-B523-861A3556A9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F47A19-F976-4AD1-B694-1273C60DD8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33DD58-6B58-4BB3-B1EB-6E9FC72951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1B60C9-867E-4019-8DA5-8557A1890C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0F18A99-4AA8-4996-92CE-07618104D782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subTitle"/>
          </p:nvPr>
        </p:nvSpPr>
        <p:spPr>
          <a:xfrm>
            <a:off x="250560" y="4941360"/>
            <a:ext cx="8569080" cy="23036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algn="just">
              <a:lnSpc>
                <a:spcPct val="80000"/>
              </a:lnSpc>
              <a:spcBef>
                <a:spcPts val="3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gure S1.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qPCR analysis of the EMT markers ZEB2 and SNAI1 in Syndecan-1 and control siRNA transfected MDA-MB-231 and MCF-7 cells reveals no significant expression differences. Data are shown as fold change of expression in Syndecan-1 siRNA treated compared to control siRNA treated cells (n=3, P&gt;0.05 (n.s.)). qPCR was performed essentially as previously described [Ibrahim SA et al. Int J Cancer 131:E884-896] using the following primers: ZEB2: </a:t>
            </a: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fw: TGGGCTAGTAGGCTGTGTCCA , rev: TCATCTTCAACCCTGAAACAGAGG;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NAI1: fw:</a:t>
            </a: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CCTGTTTCCCGGGCAATTTA, rev: TTCTGGGAGACACATCGGTCA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Object 6"/>
          <p:cNvGraphicFramePr/>
          <p:nvPr/>
        </p:nvGraphicFramePr>
        <p:xfrm>
          <a:off x="250920" y="189000"/>
          <a:ext cx="9540720" cy="454644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3" name="Object 6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50920" y="189000"/>
                    <a:ext cx="9540720" cy="4546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1-18T15:32:45Z</dcterms:created>
  <dc:creator>Admin</dc:creator>
  <dc:description/>
  <dc:language>en-US</dc:language>
  <cp:lastModifiedBy>Greve</cp:lastModifiedBy>
  <dcterms:modified xsi:type="dcterms:W3CDTF">2013-12-11T11:36:50Z</dcterms:modified>
  <cp:revision>7</cp:revision>
  <dc:subject/>
  <dc:title>Folie 1</dc:title>
</cp:coreProperties>
</file>